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B5BF59-A56B-4649-9F71-45D98F72360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E43296-0B4E-46F6-BC36-8B6E83FA83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240CB5-934D-4BE3-BED1-0D15A3EF375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D92A85-B193-4506-961D-AAFD3424626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0817ED-0508-4F29-9E4C-E9A8E94BAD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FC94C3-3936-47F6-99EB-BD96D40394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C96DBB-016D-4C00-A8D7-C1E588B8B87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B9FA95-3D31-453D-B813-EC40486BB68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354966-7209-45F0-AF30-683D7C21199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04DC65-46DB-419A-A1BF-7B822F70A2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BF9F0D-CFBB-4315-BDDE-1441420714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70DF3A-17C7-45ED-840B-B40F01BCDF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4A512F1-1BA9-49BB-969C-73F71244367D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077840" y="3144960"/>
            <a:ext cx="4837320" cy="135720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1071720" y="4538520"/>
            <a:ext cx="4827600" cy="135756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1490040" y="2916360"/>
            <a:ext cx="1022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PMingLiU"/>
              </a:rPr>
              <a:t>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PMingLiU"/>
              </a:rPr>
              <a:t>GFP imag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2935800" y="2916360"/>
            <a:ext cx="119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PMingLiU"/>
              </a:rPr>
              <a:t>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PMingLiU"/>
              </a:rPr>
              <a:t>GalNT7 stainin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4896000" y="2916360"/>
            <a:ext cx="64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PMingLiU"/>
              </a:rPr>
              <a:t>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PMingLiU"/>
              </a:rPr>
              <a:t>merge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986400" y="4289400"/>
            <a:ext cx="576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66"/>
                </a:solidFill>
                <a:latin typeface="Arial"/>
                <a:ea typeface="PMingLiU"/>
              </a:rPr>
              <a:t>   </a:t>
            </a:r>
            <a:r>
              <a:rPr b="0" lang="en-US" sz="800" spc="-1" strike="noStrike">
                <a:solidFill>
                  <a:srgbClr val="ff0066"/>
                </a:solidFill>
                <a:latin typeface="Arial"/>
                <a:ea typeface="PMingLiU"/>
              </a:rPr>
              <a:t>20</a:t>
            </a:r>
            <a:r>
              <a:rPr b="0" lang="en-US" sz="800" spc="-1" strike="noStrike">
                <a:solidFill>
                  <a:srgbClr val="ff0066"/>
                </a:solidFill>
                <a:latin typeface="Symbol"/>
                <a:ea typeface="Symbol"/>
              </a:rPr>
              <a:t></a:t>
            </a:r>
            <a:r>
              <a:rPr b="0" lang="en-US" sz="800" spc="-1" strike="noStrike">
                <a:solidFill>
                  <a:srgbClr val="ff0066"/>
                </a:solidFill>
                <a:latin typeface="Arial"/>
                <a:ea typeface="PMingLiU"/>
              </a:rPr>
              <a:t>m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978480" y="5707080"/>
            <a:ext cx="576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66"/>
                </a:solidFill>
                <a:latin typeface="Arial"/>
                <a:ea typeface="PMingLiU"/>
              </a:rPr>
              <a:t>   </a:t>
            </a:r>
            <a:r>
              <a:rPr b="0" lang="en-US" sz="800" spc="-1" strike="noStrike">
                <a:solidFill>
                  <a:srgbClr val="ff0066"/>
                </a:solidFill>
                <a:latin typeface="Arial"/>
                <a:ea typeface="PMingLiU"/>
              </a:rPr>
              <a:t>20</a:t>
            </a:r>
            <a:r>
              <a:rPr b="0" lang="en-US" sz="800" spc="-1" strike="noStrike">
                <a:solidFill>
                  <a:srgbClr val="ff0066"/>
                </a:solidFill>
                <a:latin typeface="Symbol"/>
                <a:ea typeface="Symbol"/>
              </a:rPr>
              <a:t></a:t>
            </a:r>
            <a:r>
              <a:rPr b="0" lang="en-US" sz="800" spc="-1" strike="noStrike">
                <a:solidFill>
                  <a:srgbClr val="ff0066"/>
                </a:solidFill>
                <a:latin typeface="Arial"/>
                <a:ea typeface="PMingLiU"/>
              </a:rPr>
              <a:t>m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476640" y="3751200"/>
            <a:ext cx="50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PMingLiU"/>
              </a:rPr>
              <a:t>   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PMingLiU"/>
              </a:rPr>
              <a:t>GFP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472680" y="5048280"/>
            <a:ext cx="651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PMingLiU"/>
              </a:rPr>
              <a:t>  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PMingLiU"/>
              </a:rPr>
              <a:t>miR-378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50" name=""/>
          <p:cNvGrpSpPr/>
          <p:nvPr/>
        </p:nvGrpSpPr>
        <p:grpSpPr>
          <a:xfrm>
            <a:off x="2139840" y="6200640"/>
            <a:ext cx="3233520" cy="1474920"/>
            <a:chOff x="2139840" y="6200640"/>
            <a:chExt cx="3233520" cy="1474920"/>
          </a:xfrm>
        </p:grpSpPr>
        <p:sp>
          <p:nvSpPr>
            <p:cNvPr id="51" name=""/>
            <p:cNvSpPr/>
            <p:nvPr/>
          </p:nvSpPr>
          <p:spPr>
            <a:xfrm>
              <a:off x="2365200" y="6280200"/>
              <a:ext cx="250920" cy="137160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000240" y="7500960"/>
              <a:ext cx="252360" cy="15084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3636720" y="7500960"/>
              <a:ext cx="265320" cy="15084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4286160" y="7500960"/>
              <a:ext cx="252360" cy="15084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4922640" y="7397640"/>
              <a:ext cx="252360" cy="25416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 flipV="1">
              <a:off x="2484360" y="6224040"/>
              <a:ext cx="1440" cy="55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444760" y="6224400"/>
              <a:ext cx="9180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"/>
            <p:cNvSpPr/>
            <p:nvPr/>
          </p:nvSpPr>
          <p:spPr>
            <a:xfrm flipV="1">
              <a:off x="3120840" y="7477200"/>
              <a:ext cx="144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3081240" y="7477200"/>
              <a:ext cx="92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"/>
            <p:cNvSpPr/>
            <p:nvPr/>
          </p:nvSpPr>
          <p:spPr>
            <a:xfrm flipV="1">
              <a:off x="3770280" y="7477200"/>
              <a:ext cx="144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3730320" y="7477200"/>
              <a:ext cx="92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"/>
            <p:cNvSpPr/>
            <p:nvPr/>
          </p:nvSpPr>
          <p:spPr>
            <a:xfrm flipV="1">
              <a:off x="4405320" y="7477200"/>
              <a:ext cx="288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4365360" y="7477200"/>
              <a:ext cx="936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"/>
            <p:cNvSpPr/>
            <p:nvPr/>
          </p:nvSpPr>
          <p:spPr>
            <a:xfrm flipV="1">
              <a:off x="5041800" y="7365960"/>
              <a:ext cx="324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5002200" y="7365960"/>
              <a:ext cx="936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2179440" y="6200640"/>
              <a:ext cx="1800" cy="145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2152440" y="7651800"/>
              <a:ext cx="270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2152440" y="7540560"/>
              <a:ext cx="270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2152440" y="7421400"/>
              <a:ext cx="2700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2152440" y="7310520"/>
              <a:ext cx="270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2152440" y="7199280"/>
              <a:ext cx="270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2152440" y="7088040"/>
              <a:ext cx="2700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2152440" y="6968880"/>
              <a:ext cx="2700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2152440" y="6858000"/>
              <a:ext cx="270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2152440" y="6748560"/>
              <a:ext cx="27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2152440" y="6629400"/>
              <a:ext cx="27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2152440" y="6518160"/>
              <a:ext cx="2700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2152440" y="6406920"/>
              <a:ext cx="2700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2152440" y="6288120"/>
              <a:ext cx="270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2139840" y="7651800"/>
              <a:ext cx="396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2139840" y="7421400"/>
              <a:ext cx="3960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2139840" y="7199280"/>
              <a:ext cx="396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2139840" y="6968880"/>
              <a:ext cx="3960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2139840" y="6748560"/>
              <a:ext cx="39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2139840" y="6518160"/>
              <a:ext cx="3960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2139840" y="6288120"/>
              <a:ext cx="396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2179440" y="7651800"/>
              <a:ext cx="31939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"/>
            <p:cNvSpPr/>
            <p:nvPr/>
          </p:nvSpPr>
          <p:spPr>
            <a:xfrm flipV="1">
              <a:off x="2179440" y="7651800"/>
              <a:ext cx="180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89" name=""/>
          <p:cNvSpPr/>
          <p:nvPr/>
        </p:nvSpPr>
        <p:spPr>
          <a:xfrm>
            <a:off x="1994040" y="759636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"/>
          <p:cNvSpPr/>
          <p:nvPr/>
        </p:nvSpPr>
        <p:spPr>
          <a:xfrm>
            <a:off x="1851480" y="736596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0.05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"/>
          <p:cNvSpPr/>
          <p:nvPr/>
        </p:nvSpPr>
        <p:spPr>
          <a:xfrm>
            <a:off x="1908000" y="714384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0.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"/>
          <p:cNvSpPr/>
          <p:nvPr/>
        </p:nvSpPr>
        <p:spPr>
          <a:xfrm>
            <a:off x="1851480" y="691344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0.15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"/>
          <p:cNvSpPr/>
          <p:nvPr/>
        </p:nvSpPr>
        <p:spPr>
          <a:xfrm>
            <a:off x="1908000" y="669276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"/>
          <p:cNvSpPr/>
          <p:nvPr/>
        </p:nvSpPr>
        <p:spPr>
          <a:xfrm>
            <a:off x="1851480" y="646272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0.25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>
            <a:off x="1908000" y="623268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0.3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 rot="19931400">
            <a:off x="2176920" y="7796520"/>
            <a:ext cx="386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  <a:ea typeface="PMingLiU"/>
              </a:rPr>
              <a:t>negativ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 rot="19960800">
            <a:off x="2635560" y="7833960"/>
            <a:ext cx="538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  <a:ea typeface="PMingLiU"/>
              </a:rPr>
              <a:t>Gal-siRNA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 rot="19960800">
            <a:off x="3285000" y="7833960"/>
            <a:ext cx="538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  <a:ea typeface="PMingLiU"/>
              </a:rPr>
              <a:t>Gal-siRNA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 rot="19960800">
            <a:off x="3921480" y="7833960"/>
            <a:ext cx="538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  <a:ea typeface="PMingLiU"/>
              </a:rPr>
              <a:t>Gal-siRNA3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 rot="19960800">
            <a:off x="4626360" y="7822800"/>
            <a:ext cx="538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  <a:ea typeface="PMingLiU"/>
              </a:rPr>
              <a:t>Gal-siRNA4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"/>
          <p:cNvSpPr/>
          <p:nvPr/>
        </p:nvSpPr>
        <p:spPr>
          <a:xfrm rot="16200000">
            <a:off x="971640" y="7020360"/>
            <a:ext cx="12549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900" spc="-1" strike="noStrike">
                <a:solidFill>
                  <a:srgbClr val="000000"/>
                </a:solidFill>
                <a:latin typeface="Arial"/>
                <a:ea typeface="PMingLiU"/>
              </a:rPr>
              <a:t>r</a:t>
            </a:r>
            <a:r>
              <a:rPr b="0" lang="en-CA" sz="900" spc="-1" strike="noStrike">
                <a:solidFill>
                  <a:srgbClr val="000000"/>
                </a:solidFill>
                <a:latin typeface="Arial"/>
              </a:rPr>
              <a:t>elative level</a:t>
            </a:r>
            <a:r>
              <a:rPr b="0" lang="en-CA" sz="900" spc="-1" strike="noStrike">
                <a:solidFill>
                  <a:srgbClr val="000000"/>
                </a:solidFill>
                <a:latin typeface="Arial"/>
                <a:ea typeface="PMingLiU"/>
              </a:rPr>
              <a:t>s</a:t>
            </a:r>
            <a:r>
              <a:rPr b="0" lang="en-CA" sz="900" spc="-1" strike="noStrike">
                <a:solidFill>
                  <a:srgbClr val="000000"/>
                </a:solidFill>
                <a:latin typeface="Arial"/>
              </a:rPr>
              <a:t> of GalN</a:t>
            </a:r>
            <a:r>
              <a:rPr b="0" lang="en-CA" sz="900" spc="-1" strike="noStrike">
                <a:solidFill>
                  <a:srgbClr val="000000"/>
                </a:solidFill>
                <a:latin typeface="Arial"/>
                <a:ea typeface="PMingLiU"/>
              </a:rPr>
              <a:t>T</a:t>
            </a:r>
            <a:r>
              <a:rPr b="0" lang="en-CA" sz="9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>
            <a:off x="1276200" y="1035720"/>
            <a:ext cx="50403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 u="sng">
                <a:solidFill>
                  <a:srgbClr val="000000"/>
                </a:solidFill>
                <a:uFillTx/>
                <a:latin typeface="Courier New"/>
                <a:ea typeface="宋体"/>
              </a:rPr>
              <a:t>ACTAGT</a:t>
            </a:r>
            <a:r>
              <a:rPr b="0" lang="en-CA" sz="1000" spc="-1" strike="noStrike">
                <a:solidFill>
                  <a:srgbClr val="000000"/>
                </a:solidFill>
                <a:latin typeface="Courier New"/>
                <a:ea typeface="宋体"/>
              </a:rPr>
              <a:t>gcccttgttagattaggccttataaaacttgtgtgcattataacctaagctgtgcaacctgtgaagccaagagtgaactgatgtttcatttatattttcatccaaatgacattatctgcacgtttttaaaatttaaaaacaaaggactatttaaaaatacagtttattaacaaacgtgaactactttctgttacattaggtgttccctagtgtttcttaatttctttttagaaagtgtatttttattagtatttttccggtgaacagaagatttgtttggatttaaacatttacta</a:t>
            </a:r>
            <a:r>
              <a:rPr b="1" lang="en-CA" sz="1000" spc="-1" strike="noStrike">
                <a:solidFill>
                  <a:srgbClr val="3333cc"/>
                </a:solidFill>
                <a:latin typeface="Courier New"/>
                <a:ea typeface="宋体"/>
              </a:rPr>
              <a:t>agacagtacctattaggaa</a:t>
            </a:r>
            <a:r>
              <a:rPr b="0" lang="en-CA" sz="1000" spc="-1" strike="noStrike">
                <a:solidFill>
                  <a:srgbClr val="000000"/>
                </a:solidFill>
                <a:latin typeface="Courier New"/>
                <a:ea typeface="宋体"/>
              </a:rPr>
              <a:t>aaccaaatattgcaaatg</a:t>
            </a:r>
            <a:r>
              <a:rPr b="0" lang="en-CA" sz="1000" spc="-1" strike="noStrike">
                <a:solidFill>
                  <a:srgbClr val="000000"/>
                </a:solidFill>
                <a:latin typeface="Courier New"/>
                <a:ea typeface="PMingLiU"/>
              </a:rPr>
              <a:t> </a:t>
            </a:r>
            <a:r>
              <a:rPr b="1" lang="en-CA" sz="1000" spc="-1" strike="noStrike" u="sng">
                <a:solidFill>
                  <a:srgbClr val="000000"/>
                </a:solidFill>
                <a:uFillTx/>
                <a:latin typeface="Courier New"/>
                <a:ea typeface="宋体"/>
              </a:rPr>
              <a:t>ACGCG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>
            <a:off x="486000" y="1203480"/>
            <a:ext cx="758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Narrow"/>
                <a:ea typeface="宋体"/>
              </a:rPr>
              <a:t>luc-Gal-UTR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>
            <a:off x="511560" y="2144880"/>
            <a:ext cx="718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Narrow"/>
                <a:ea typeface="宋体"/>
              </a:rPr>
              <a:t>luc-Gal-mu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 flipH="1">
            <a:off x="1380960" y="750960"/>
            <a:ext cx="2105280" cy="31896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"/>
          <p:cNvSpPr/>
          <p:nvPr/>
        </p:nvSpPr>
        <p:spPr>
          <a:xfrm>
            <a:off x="4175280" y="731880"/>
            <a:ext cx="2052360" cy="36360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"/>
          <p:cNvSpPr/>
          <p:nvPr/>
        </p:nvSpPr>
        <p:spPr>
          <a:xfrm>
            <a:off x="2239920" y="609480"/>
            <a:ext cx="201600" cy="171720"/>
          </a:xfrm>
          <a:prstGeom prst="rightArrow">
            <a:avLst>
              <a:gd name="adj1" fmla="val 50000"/>
              <a:gd name="adj2" fmla="val 29350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240" bIns="392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"/>
          <p:cNvSpPr/>
          <p:nvPr/>
        </p:nvSpPr>
        <p:spPr>
          <a:xfrm>
            <a:off x="1760400" y="695160"/>
            <a:ext cx="3713400" cy="97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"/>
          <p:cNvSpPr/>
          <p:nvPr/>
        </p:nvSpPr>
        <p:spPr>
          <a:xfrm>
            <a:off x="2459160" y="647640"/>
            <a:ext cx="934920" cy="1065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"/>
          <p:cNvSpPr/>
          <p:nvPr/>
        </p:nvSpPr>
        <p:spPr>
          <a:xfrm>
            <a:off x="3497400" y="646200"/>
            <a:ext cx="752400" cy="108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"/>
          <p:cNvSpPr/>
          <p:nvPr/>
        </p:nvSpPr>
        <p:spPr>
          <a:xfrm>
            <a:off x="1021680" y="566640"/>
            <a:ext cx="790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宋体"/>
              </a:rPr>
              <a:t>pMiR-Reporter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"/>
          <p:cNvSpPr/>
          <p:nvPr/>
        </p:nvSpPr>
        <p:spPr>
          <a:xfrm rot="2234400">
            <a:off x="2806200" y="531720"/>
            <a:ext cx="87480" cy="324000"/>
          </a:xfrm>
          <a:custGeom>
            <a:avLst/>
            <a:gdLst/>
            <a:ahLst/>
            <a:rect l="l" t="t" r="r" b="b"/>
            <a:pathLst>
              <a:path w="144" h="240">
                <a:moveTo>
                  <a:pt x="96" y="0"/>
                </a:moveTo>
                <a:lnTo>
                  <a:pt x="0" y="144"/>
                </a:lnTo>
                <a:lnTo>
                  <a:pt x="144" y="96"/>
                </a:lnTo>
                <a:lnTo>
                  <a:pt x="48" y="240"/>
                </a:lnTo>
              </a:path>
            </a:pathLst>
          </a:custGeom>
          <a:blipFill rotWithShape="0">
            <a:blip r:embed="rId3"/>
            <a:srcRect/>
            <a:tile tx="0" ty="0" sx="100000" sy="100000" algn="ctr"/>
          </a:blipFill>
          <a:ln w="284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"/>
          <p:cNvSpPr/>
          <p:nvPr/>
        </p:nvSpPr>
        <p:spPr>
          <a:xfrm rot="18642600">
            <a:off x="2551680" y="262800"/>
            <a:ext cx="68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luciferas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"/>
          <p:cNvSpPr/>
          <p:nvPr/>
        </p:nvSpPr>
        <p:spPr>
          <a:xfrm rot="18637800">
            <a:off x="1802520" y="359640"/>
            <a:ext cx="452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CMV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"/>
          <p:cNvSpPr/>
          <p:nvPr/>
        </p:nvSpPr>
        <p:spPr>
          <a:xfrm>
            <a:off x="2463840" y="582480"/>
            <a:ext cx="0" cy="108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"/>
          <p:cNvSpPr/>
          <p:nvPr/>
        </p:nvSpPr>
        <p:spPr>
          <a:xfrm rot="16200000">
            <a:off x="2219040" y="337680"/>
            <a:ext cx="438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 Narrow"/>
                <a:ea typeface="宋体"/>
              </a:rPr>
              <a:t>BamHI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"/>
          <p:cNvSpPr/>
          <p:nvPr/>
        </p:nvSpPr>
        <p:spPr>
          <a:xfrm rot="16138800">
            <a:off x="3328920" y="332280"/>
            <a:ext cx="348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 Narrow"/>
                <a:ea typeface="宋体"/>
              </a:rPr>
              <a:t>SacI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"/>
          <p:cNvSpPr/>
          <p:nvPr/>
        </p:nvSpPr>
        <p:spPr>
          <a:xfrm rot="16128600">
            <a:off x="5209200" y="357840"/>
            <a:ext cx="334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 Narrow"/>
                <a:ea typeface="宋体"/>
              </a:rPr>
              <a:t>NotI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"/>
          <p:cNvSpPr/>
          <p:nvPr/>
        </p:nvSpPr>
        <p:spPr>
          <a:xfrm>
            <a:off x="3497400" y="574560"/>
            <a:ext cx="0" cy="108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"/>
          <p:cNvSpPr/>
          <p:nvPr/>
        </p:nvSpPr>
        <p:spPr>
          <a:xfrm rot="18636000">
            <a:off x="4722480" y="339840"/>
            <a:ext cx="536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poly(A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"/>
          <p:cNvSpPr/>
          <p:nvPr/>
        </p:nvSpPr>
        <p:spPr>
          <a:xfrm>
            <a:off x="4843440" y="647640"/>
            <a:ext cx="282600" cy="108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"/>
          <p:cNvSpPr/>
          <p:nvPr/>
        </p:nvSpPr>
        <p:spPr>
          <a:xfrm rot="18630600">
            <a:off x="3672000" y="330120"/>
            <a:ext cx="532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3’UTR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"/>
          <p:cNvSpPr/>
          <p:nvPr/>
        </p:nvSpPr>
        <p:spPr>
          <a:xfrm>
            <a:off x="1865160" y="646200"/>
            <a:ext cx="527040" cy="1047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"/>
          <p:cNvSpPr/>
          <p:nvPr/>
        </p:nvSpPr>
        <p:spPr>
          <a:xfrm rot="16138800">
            <a:off x="4385880" y="300240"/>
            <a:ext cx="423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 Narrow"/>
                <a:ea typeface="宋体"/>
              </a:rPr>
              <a:t>HindIII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"/>
          <p:cNvSpPr/>
          <p:nvPr/>
        </p:nvSpPr>
        <p:spPr>
          <a:xfrm>
            <a:off x="5394240" y="581040"/>
            <a:ext cx="0" cy="108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"/>
          <p:cNvSpPr/>
          <p:nvPr/>
        </p:nvSpPr>
        <p:spPr>
          <a:xfrm rot="16128600">
            <a:off x="4233960" y="344520"/>
            <a:ext cx="339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 Narrow"/>
                <a:ea typeface="宋体"/>
              </a:rPr>
              <a:t>MluI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"/>
          <p:cNvSpPr/>
          <p:nvPr/>
        </p:nvSpPr>
        <p:spPr>
          <a:xfrm>
            <a:off x="4395960" y="573120"/>
            <a:ext cx="0" cy="108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"/>
          <p:cNvSpPr/>
          <p:nvPr/>
        </p:nvSpPr>
        <p:spPr>
          <a:xfrm>
            <a:off x="4594320" y="576360"/>
            <a:ext cx="0" cy="108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"/>
          <p:cNvSpPr/>
          <p:nvPr/>
        </p:nvSpPr>
        <p:spPr>
          <a:xfrm>
            <a:off x="3432240" y="588960"/>
            <a:ext cx="0" cy="108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"/>
          <p:cNvSpPr/>
          <p:nvPr/>
        </p:nvSpPr>
        <p:spPr>
          <a:xfrm rot="16138800">
            <a:off x="3227760" y="333360"/>
            <a:ext cx="354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 Narrow"/>
                <a:ea typeface="宋体"/>
              </a:rPr>
              <a:t>SpeI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"/>
          <p:cNvSpPr/>
          <p:nvPr/>
        </p:nvSpPr>
        <p:spPr>
          <a:xfrm>
            <a:off x="1276200" y="1875600"/>
            <a:ext cx="50403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 u="sng">
                <a:solidFill>
                  <a:srgbClr val="000000"/>
                </a:solidFill>
                <a:uFillTx/>
                <a:latin typeface="Courier New"/>
                <a:ea typeface="宋体"/>
              </a:rPr>
              <a:t>ACTAGT</a:t>
            </a:r>
            <a:r>
              <a:rPr b="0" lang="en-CA" sz="1000" spc="-1" strike="noStrike">
                <a:solidFill>
                  <a:srgbClr val="000000"/>
                </a:solidFill>
                <a:latin typeface="Courier New"/>
                <a:ea typeface="宋体"/>
              </a:rPr>
              <a:t>gcccttgttagattaggccttataaaacttgtgtgcattataacctaagctgtgcaacctgtgaagccaagagtgaactgatgtttcatttatattttcatccaaatgacattatctgcacgtttttaaaatttaaaaacaaaggactatttaaaaatacagtttattaacaaacgtgaactactttctgttacattaggtgttccctagtgtttcttaatttctttttagaaagtgtatttttattagtatttttccggtgaacagaagatttgtttggatttaaacatttacta</a:t>
            </a:r>
            <a:r>
              <a:rPr b="1" lang="en-CA" sz="1000" spc="-1" strike="noStrike">
                <a:solidFill>
                  <a:srgbClr val="3333cc"/>
                </a:solidFill>
                <a:latin typeface="Courier New"/>
                <a:ea typeface="宋体"/>
              </a:rPr>
              <a:t>agacagtacctatt</a:t>
            </a:r>
            <a:r>
              <a:rPr b="1" lang="en-CA" sz="1000" spc="-1" strike="noStrike">
                <a:solidFill>
                  <a:srgbClr val="ff0066"/>
                </a:solidFill>
                <a:latin typeface="Courier New"/>
                <a:ea typeface="宋体"/>
              </a:rPr>
              <a:t>agga</a:t>
            </a:r>
            <a:r>
              <a:rPr b="1" lang="en-CA" sz="1000" spc="-1" strike="noStrike">
                <a:solidFill>
                  <a:srgbClr val="3333cc"/>
                </a:solidFill>
                <a:latin typeface="Courier New"/>
                <a:ea typeface="宋体"/>
              </a:rPr>
              <a:t>a</a:t>
            </a:r>
            <a:r>
              <a:rPr b="0" lang="en-CA" sz="1000" spc="-1" strike="noStrike">
                <a:solidFill>
                  <a:srgbClr val="000000"/>
                </a:solidFill>
                <a:latin typeface="Courier New"/>
                <a:ea typeface="宋体"/>
              </a:rPr>
              <a:t>aaccaaatattgcaaatg</a:t>
            </a:r>
            <a:r>
              <a:rPr b="0" lang="en-CA" sz="1000" spc="-1" strike="noStrike">
                <a:solidFill>
                  <a:srgbClr val="000000"/>
                </a:solidFill>
                <a:latin typeface="Courier New"/>
                <a:ea typeface="PMingLiU"/>
              </a:rPr>
              <a:t> </a:t>
            </a:r>
            <a:r>
              <a:rPr b="1" lang="en-CA" sz="1000" spc="-1" strike="noStrike" u="sng">
                <a:solidFill>
                  <a:srgbClr val="000000"/>
                </a:solidFill>
                <a:uFillTx/>
                <a:latin typeface="Courier New"/>
                <a:ea typeface="宋体"/>
              </a:rPr>
              <a:t>ACGCG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"/>
          <p:cNvSpPr/>
          <p:nvPr/>
        </p:nvSpPr>
        <p:spPr>
          <a:xfrm>
            <a:off x="469800" y="291636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2000" spc="-1" strike="noStrike">
                <a:solidFill>
                  <a:srgbClr val="000000"/>
                </a:solidFill>
                <a:latin typeface="Arial"/>
                <a:ea typeface="PMingLiU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"/>
          <p:cNvSpPr/>
          <p:nvPr/>
        </p:nvSpPr>
        <p:spPr>
          <a:xfrm>
            <a:off x="477720" y="619128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2000" spc="-1" strike="noStrike">
                <a:solidFill>
                  <a:srgbClr val="000000"/>
                </a:solidFill>
                <a:latin typeface="Arial"/>
                <a:ea typeface="PMingLiU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"/>
          <p:cNvSpPr/>
          <p:nvPr/>
        </p:nvSpPr>
        <p:spPr>
          <a:xfrm>
            <a:off x="477720" y="7128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2000" spc="-1" strike="noStrike">
                <a:solidFill>
                  <a:srgbClr val="000000"/>
                </a:solidFill>
                <a:latin typeface="Arial"/>
                <a:ea typeface="PMingLiU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9-11T16:33:30Z</dcterms:created>
  <dc:creator>byang</dc:creator>
  <dc:description/>
  <dc:language>en-US</dc:language>
  <cp:lastModifiedBy>B. Yang</cp:lastModifiedBy>
  <dcterms:modified xsi:type="dcterms:W3CDTF">2009-10-05T18:12:25Z</dcterms:modified>
  <cp:revision>58</cp:revision>
  <dc:subject/>
  <dc:title>PowerPoint Presentation</dc:title>
</cp:coreProperties>
</file>